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AC9C8A-1935-499F-A52B-17F4BF3396F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B2EFC8-14D1-4A9D-9C30-ED71B1E5B1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751632-A0CF-4806-846D-634713CE2D8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1EC486-063C-4EF1-ABB7-D4DEFFEC630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3C5F65-859E-4590-8153-552962218F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536189-D164-4D26-BCAE-1FC89B61CD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C8D68D-6400-4443-B53C-F71D956EBC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FBD5D6-28BF-4526-A128-4CEAC6871C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303F69-E4A3-48FF-8897-DC10BDD437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AF453C-0F6A-4EEA-A861-440B8D22E2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ECE4B4-DC27-4456-990F-D7908DE6B5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7335BC-57EB-4CB5-B758-D44F533C1C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7D340B-58BB-42CD-AD64-69619BA0E399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200320" y="1454040"/>
            <a:ext cx="37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2570040" y="1454040"/>
            <a:ext cx="40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h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2872440" y="145080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h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3177720" y="145080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2h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3499920" y="145080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4h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3837960" y="145080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8h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2975400" y="1249200"/>
            <a:ext cx="88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 nM DBZ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1928520" y="145404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4329360" y="1649520"/>
            <a:ext cx="581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es1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4232520" y="1962000"/>
            <a:ext cx="826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ncleaved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ARP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4358160" y="255420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Erk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4358160" y="243828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Erk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4342680" y="2890800"/>
            <a:ext cx="5601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Ak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S473)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4279680" y="3778200"/>
            <a:ext cx="552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ct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4279320" y="336384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cl-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5318280" y="1452600"/>
            <a:ext cx="37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5676840" y="1454040"/>
            <a:ext cx="40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h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6006240" y="145404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h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6292440" y="145404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2h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6648120" y="146196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4h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6978240" y="145584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8h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5895360" y="1257480"/>
            <a:ext cx="110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 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  L-685,45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5027400" y="14526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4184640" y="2162160"/>
            <a:ext cx="260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4216320" y="25938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4216320" y="263196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4832280" y="25938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4832280" y="263196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2577960" y="1457280"/>
            <a:ext cx="1613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5715000" y="1461960"/>
            <a:ext cx="1600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4226040" y="38988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4216320" y="346716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4203720" y="30607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 flipV="1">
            <a:off x="4178160" y="1766880"/>
            <a:ext cx="2667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4800600" y="39085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4819680" y="347976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4800600" y="30510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4813200" y="216216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4813200" y="17668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80" name="" descr=""/>
          <p:cNvPicPr/>
          <p:nvPr/>
        </p:nvPicPr>
        <p:blipFill>
          <a:blip r:embed="rId1"/>
          <a:srcRect l="0" t="19881" r="0" b="0"/>
          <a:stretch/>
        </p:blipFill>
        <p:spPr>
          <a:xfrm>
            <a:off x="1905120" y="1682640"/>
            <a:ext cx="2286000" cy="169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1" name="" descr=""/>
          <p:cNvPicPr/>
          <p:nvPr/>
        </p:nvPicPr>
        <p:blipFill>
          <a:blip r:embed="rId2"/>
          <a:stretch/>
        </p:blipFill>
        <p:spPr>
          <a:xfrm>
            <a:off x="1905120" y="2057400"/>
            <a:ext cx="2286000" cy="2491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2" name="" descr=""/>
          <p:cNvPicPr/>
          <p:nvPr/>
        </p:nvPicPr>
        <p:blipFill>
          <a:blip r:embed="rId3"/>
          <a:stretch/>
        </p:blipFill>
        <p:spPr>
          <a:xfrm>
            <a:off x="1905120" y="2533680"/>
            <a:ext cx="2286000" cy="1936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3" name="" descr=""/>
          <p:cNvPicPr/>
          <p:nvPr/>
        </p:nvPicPr>
        <p:blipFill>
          <a:blip r:embed="rId4"/>
          <a:stretch/>
        </p:blipFill>
        <p:spPr>
          <a:xfrm>
            <a:off x="1914480" y="2962440"/>
            <a:ext cx="2286000" cy="209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4" name="" descr=""/>
          <p:cNvPicPr/>
          <p:nvPr/>
        </p:nvPicPr>
        <p:blipFill>
          <a:blip r:embed="rId5"/>
          <a:srcRect l="0" t="19685" r="0" b="0"/>
          <a:stretch/>
        </p:blipFill>
        <p:spPr>
          <a:xfrm>
            <a:off x="1914480" y="3411360"/>
            <a:ext cx="2286000" cy="169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5" name="" descr=""/>
          <p:cNvPicPr/>
          <p:nvPr/>
        </p:nvPicPr>
        <p:blipFill>
          <a:blip r:embed="rId6"/>
          <a:stretch/>
        </p:blipFill>
        <p:spPr>
          <a:xfrm>
            <a:off x="1924200" y="3795840"/>
            <a:ext cx="2286000" cy="244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6" name="" descr=""/>
          <p:cNvPicPr/>
          <p:nvPr/>
        </p:nvPicPr>
        <p:blipFill>
          <a:blip r:embed="rId7"/>
          <a:srcRect l="0" t="21882" r="0" b="0"/>
          <a:stretch/>
        </p:blipFill>
        <p:spPr>
          <a:xfrm>
            <a:off x="5045040" y="1698480"/>
            <a:ext cx="2286000" cy="1494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7" name="" descr=""/>
          <p:cNvPicPr/>
          <p:nvPr/>
        </p:nvPicPr>
        <p:blipFill>
          <a:blip r:embed="rId8"/>
          <a:stretch/>
        </p:blipFill>
        <p:spPr>
          <a:xfrm>
            <a:off x="5054760" y="2058840"/>
            <a:ext cx="2286000" cy="2588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8" name="" descr=""/>
          <p:cNvPicPr/>
          <p:nvPr/>
        </p:nvPicPr>
        <p:blipFill>
          <a:blip r:embed="rId9"/>
          <a:stretch/>
        </p:blipFill>
        <p:spPr>
          <a:xfrm>
            <a:off x="5054760" y="2543040"/>
            <a:ext cx="2286000" cy="182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9" name="" descr=""/>
          <p:cNvPicPr/>
          <p:nvPr/>
        </p:nvPicPr>
        <p:blipFill>
          <a:blip r:embed="rId10"/>
          <a:stretch/>
        </p:blipFill>
        <p:spPr>
          <a:xfrm>
            <a:off x="5045040" y="2959200"/>
            <a:ext cx="2286000" cy="176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90" name="" descr=""/>
          <p:cNvPicPr/>
          <p:nvPr/>
        </p:nvPicPr>
        <p:blipFill>
          <a:blip r:embed="rId11"/>
          <a:stretch/>
        </p:blipFill>
        <p:spPr>
          <a:xfrm>
            <a:off x="5054760" y="3381480"/>
            <a:ext cx="2286000" cy="190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91" name="" descr=""/>
          <p:cNvPicPr/>
          <p:nvPr/>
        </p:nvPicPr>
        <p:blipFill>
          <a:blip r:embed="rId12"/>
          <a:stretch/>
        </p:blipFill>
        <p:spPr>
          <a:xfrm>
            <a:off x="5054760" y="3789360"/>
            <a:ext cx="2286000" cy="2397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92" name=""/>
          <p:cNvSpPr/>
          <p:nvPr/>
        </p:nvSpPr>
        <p:spPr>
          <a:xfrm>
            <a:off x="1779480" y="2228760"/>
            <a:ext cx="111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 rot="66000">
            <a:off x="1537200" y="210456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1779480" y="2546280"/>
            <a:ext cx="111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 rot="66000">
            <a:off x="1537200" y="24220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1787400" y="2998800"/>
            <a:ext cx="111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 rot="66000">
            <a:off x="1545120" y="287460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1787400" y="3416400"/>
            <a:ext cx="111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 rot="66000">
            <a:off x="1545120" y="329220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1795320" y="3809880"/>
            <a:ext cx="111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 rot="66000">
            <a:off x="1553040" y="36856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1779480" y="1843200"/>
            <a:ext cx="111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 rot="66000">
            <a:off x="1537200" y="171900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990720" y="4648320"/>
            <a:ext cx="723888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Molecular effects of </a:t>
            </a:r>
            <a:r>
              <a:rPr b="1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-secretase inhibition on signalling proteins involved in regulating cell growth or death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HCA-7 cells were either left untreated (0), treated with DMSO as a control (DM) or incubated with the 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-secretase inhibitors as indicated. Cells were lysed in RIPA buffer and 50 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g of total protein was subjected to immunoblotting analysis as specified. Both inhibitors result in the down-regulation of Hes1 expression from approximately 12 h. PARP, an indicator of cell death when cleaved, was also analysed and undetectable with both inhibitors A late increase of pErk (pT202pY204) and pAkt (pS473) is evident. In addition, a slight down-regulation of anti-apoptotic Bcl-2 protein was detectable with DBZ. Actin was analysed as a loading control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8-22T13:03:35Z</dcterms:created>
  <dc:creator>pthomas cruk</dc:creator>
  <dc:description/>
  <dc:language>en-US</dc:language>
  <cp:lastModifiedBy>crukuser</cp:lastModifiedBy>
  <cp:lastPrinted>2008-10-09T13:42:18Z</cp:lastPrinted>
  <dcterms:modified xsi:type="dcterms:W3CDTF">2008-10-23T10:45:21Z</dcterms:modified>
  <cp:revision>74</cp:revision>
  <dc:subject/>
  <dc:title>PowerPoint Presentation</dc:title>
</cp:coreProperties>
</file>